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87A53-B65A-4201-AE02-71C7DC3C8E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1DDED-2917-4E2B-8260-3EAB0ADC19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98D13-ACC6-484D-BD50-75768FCA66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8D436-197E-4E2D-B8C5-281E268970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C0F859-DB92-418E-A33B-719DA69C60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C52C1-DBB4-41FE-BE87-9271A122CD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AC5B3-7379-47AC-A668-609ED8E680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DFD346-9ADB-4C9C-B8A8-13F8F68189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D0CAC-6543-4002-83B2-BA37B25FFC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5A2CA-0D85-4C96-A6A6-DCBB9B4E63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73169-FC42-43F0-924C-1E3583521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3281D-DAA1-4885-8301-8011F930FA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F522E7-161B-4B13-A049-0780C8F338B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905120" y="3224160"/>
            <a:ext cx="2960640" cy="7668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905120" y="2332080"/>
            <a:ext cx="2954160" cy="76680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2133720" y="1959120"/>
            <a:ext cx="8506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 algn="ctr">
              <a:tabLst>
                <a:tab algn="l" pos="0"/>
                <a:tab algn="ctr" pos="311040"/>
                <a:tab algn="ctr" pos="177804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dip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019240" y="2133720"/>
            <a:ext cx="1143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505320" y="2133720"/>
            <a:ext cx="1143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 flipV="1">
            <a:off x="4876920" y="2593440"/>
            <a:ext cx="17928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H="1">
            <a:off x="4876920" y="2881440"/>
            <a:ext cx="17928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H="1" flipV="1">
            <a:off x="4876920" y="2803680"/>
            <a:ext cx="1792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010120" y="2517840"/>
            <a:ext cx="9190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>
              <a:tabLst>
                <a:tab algn="l" pos="0"/>
                <a:tab algn="ctr" pos="234648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CC2.v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010120" y="2849400"/>
            <a:ext cx="919080" cy="23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>
              <a:tabLst>
                <a:tab algn="l" pos="0"/>
                <a:tab algn="ctr" pos="234648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CC2.v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010120" y="2703600"/>
            <a:ext cx="563760" cy="23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>
              <a:tabLst>
                <a:tab algn="l" pos="0"/>
                <a:tab algn="ctr" pos="234648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C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4876920" y="3767040"/>
            <a:ext cx="17928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010120" y="3691080"/>
            <a:ext cx="9190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>
              <a:tabLst>
                <a:tab algn="l" pos="0"/>
                <a:tab algn="ctr" pos="234648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CC2.v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143000" y="3490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CC2.v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ntibod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139760" y="2590920"/>
            <a:ext cx="68868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spAutoFit/>
          </a:bodyPr>
          <a:p>
            <a:pPr algn="ctr">
              <a:tabLst>
                <a:tab algn="l" pos="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Streptavid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(anti-biotin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2600" y="22446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520" y="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352680" y="1959120"/>
            <a:ext cx="160020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 algn="ctr">
              <a:tabLst>
                <a:tab algn="l" pos="0"/>
                <a:tab algn="ctr" pos="311040"/>
                <a:tab algn="ctr" pos="177804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Adipose + Recombinant ACC2.v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828800" y="2209680"/>
            <a:ext cx="1600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 algn="ctr">
              <a:tabLst>
                <a:tab algn="l" pos="0"/>
                <a:tab algn="ctr" pos="142920"/>
                <a:tab algn="ctr" pos="879480"/>
                <a:tab algn="ctr" pos="1600200"/>
                <a:tab algn="ctr" pos="234648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	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supernatant  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	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    immunoprecipitat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352680" y="2209680"/>
            <a:ext cx="1600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noAutofit/>
          </a:bodyPr>
          <a:p>
            <a:pPr algn="ctr">
              <a:tabLst>
                <a:tab algn="l" pos="0"/>
                <a:tab algn="ctr" pos="142920"/>
                <a:tab algn="ctr" pos="879480"/>
                <a:tab algn="ctr" pos="1600200"/>
                <a:tab algn="ctr" pos="234648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	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supernatant  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	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明朝"/>
              </a:rPr>
              <a:t>    immunoprecipitat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131920" y="4038480"/>
            <a:ext cx="23292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spAutoFit/>
          </a:bodyPr>
          <a:p>
            <a:pPr algn="ctr">
              <a:tabLst>
                <a:tab algn="l" pos="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明朝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819520" y="4038480"/>
            <a:ext cx="23292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spAutoFit/>
          </a:bodyPr>
          <a:p>
            <a:pPr algn="ctr">
              <a:tabLst>
                <a:tab algn="l" pos="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明朝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569040" y="4038480"/>
            <a:ext cx="2404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spAutoFit/>
          </a:bodyPr>
          <a:p>
            <a:pPr algn="ctr">
              <a:tabLst>
                <a:tab algn="l" pos="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明朝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267440" y="4038480"/>
            <a:ext cx="240480" cy="17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4160" rIns="74160" tIns="9000" bIns="9000" anchor="t">
            <a:spAutoFit/>
          </a:bodyPr>
          <a:p>
            <a:pPr algn="ctr">
              <a:tabLst>
                <a:tab algn="l" pos="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明朝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7T16:39:31Z</dcterms:created>
  <dc:creator>John Castle</dc:creator>
  <dc:description/>
  <dc:language>en-US</dc:language>
  <cp:lastModifiedBy>Merck</cp:lastModifiedBy>
  <dcterms:modified xsi:type="dcterms:W3CDTF">2008-12-05T19:45:32Z</dcterms:modified>
  <cp:revision>16</cp:revision>
  <dc:subject/>
  <dc:title>Slide 1</dc:title>
</cp:coreProperties>
</file>